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772400" cy="10058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0F83302-0E1B-4AC7-9933-4B3C8AF54B61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88440" y="401040"/>
            <a:ext cx="6994800" cy="167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88440" y="2353320"/>
            <a:ext cx="699480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88440" y="5400360"/>
            <a:ext cx="699480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CAF95C8-7040-4381-9342-90D646B02E52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388440" y="401040"/>
            <a:ext cx="6994800" cy="167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26" name="PlaceHolder 2"/>
          <p:cNvSpPr>
            <a:spLocks noGrp="1"/>
          </p:cNvSpPr>
          <p:nvPr>
            <p:ph/>
          </p:nvPr>
        </p:nvSpPr>
        <p:spPr>
          <a:xfrm>
            <a:off x="388440" y="2353320"/>
            <a:ext cx="3413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27" name="PlaceHolder 3"/>
          <p:cNvSpPr>
            <a:spLocks noGrp="1"/>
          </p:cNvSpPr>
          <p:nvPr>
            <p:ph/>
          </p:nvPr>
        </p:nvSpPr>
        <p:spPr>
          <a:xfrm>
            <a:off x="3972600" y="2353320"/>
            <a:ext cx="3413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28" name="PlaceHolder 4"/>
          <p:cNvSpPr>
            <a:spLocks noGrp="1"/>
          </p:cNvSpPr>
          <p:nvPr>
            <p:ph/>
          </p:nvPr>
        </p:nvSpPr>
        <p:spPr>
          <a:xfrm>
            <a:off x="388440" y="5400360"/>
            <a:ext cx="3413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29" name="PlaceHolder 5"/>
          <p:cNvSpPr>
            <a:spLocks noGrp="1"/>
          </p:cNvSpPr>
          <p:nvPr>
            <p:ph/>
          </p:nvPr>
        </p:nvSpPr>
        <p:spPr>
          <a:xfrm>
            <a:off x="3972600" y="5400360"/>
            <a:ext cx="3413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F1CE2F61-7D6A-418D-8929-3EACC39DF899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388440" y="401040"/>
            <a:ext cx="6994800" cy="167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388440" y="2353320"/>
            <a:ext cx="2252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2753640" y="2353320"/>
            <a:ext cx="2252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33" name="PlaceHolder 4"/>
          <p:cNvSpPr>
            <a:spLocks noGrp="1"/>
          </p:cNvSpPr>
          <p:nvPr>
            <p:ph/>
          </p:nvPr>
        </p:nvSpPr>
        <p:spPr>
          <a:xfrm>
            <a:off x="5118840" y="2353320"/>
            <a:ext cx="2252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34" name="PlaceHolder 5"/>
          <p:cNvSpPr>
            <a:spLocks noGrp="1"/>
          </p:cNvSpPr>
          <p:nvPr>
            <p:ph/>
          </p:nvPr>
        </p:nvSpPr>
        <p:spPr>
          <a:xfrm>
            <a:off x="388440" y="5400360"/>
            <a:ext cx="2252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35" name="PlaceHolder 6"/>
          <p:cNvSpPr>
            <a:spLocks noGrp="1"/>
          </p:cNvSpPr>
          <p:nvPr>
            <p:ph/>
          </p:nvPr>
        </p:nvSpPr>
        <p:spPr>
          <a:xfrm>
            <a:off x="2753640" y="5400360"/>
            <a:ext cx="2252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36" name="PlaceHolder 7"/>
          <p:cNvSpPr>
            <a:spLocks noGrp="1"/>
          </p:cNvSpPr>
          <p:nvPr>
            <p:ph/>
          </p:nvPr>
        </p:nvSpPr>
        <p:spPr>
          <a:xfrm>
            <a:off x="5118840" y="5400360"/>
            <a:ext cx="2252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FC77D6E-FB89-4EBA-9C7F-4491E0C103FF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" name="PlaceHolder 1"/>
          <p:cNvSpPr>
            <a:spLocks noGrp="1"/>
          </p:cNvSpPr>
          <p:nvPr>
            <p:ph type="title"/>
          </p:nvPr>
        </p:nvSpPr>
        <p:spPr>
          <a:xfrm>
            <a:off x="388440" y="401040"/>
            <a:ext cx="6994800" cy="167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2" name="PlaceHolder 2"/>
          <p:cNvSpPr>
            <a:spLocks noGrp="1"/>
          </p:cNvSpPr>
          <p:nvPr>
            <p:ph type="subTitle"/>
          </p:nvPr>
        </p:nvSpPr>
        <p:spPr>
          <a:xfrm>
            <a:off x="388440" y="2353320"/>
            <a:ext cx="6994800" cy="5833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19FCBE7-AAD8-42B0-AC16-F43A4592F2EC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388440" y="401040"/>
            <a:ext cx="6994800" cy="167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/>
          </p:nvPr>
        </p:nvSpPr>
        <p:spPr>
          <a:xfrm>
            <a:off x="388440" y="2353320"/>
            <a:ext cx="6994800" cy="5833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5289DFF-3195-40F5-8C95-85FFFDFA8F36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88440" y="401040"/>
            <a:ext cx="6994800" cy="167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/>
          </p:nvPr>
        </p:nvSpPr>
        <p:spPr>
          <a:xfrm>
            <a:off x="388440" y="2353320"/>
            <a:ext cx="3413160" cy="5833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7" name="PlaceHolder 3"/>
          <p:cNvSpPr>
            <a:spLocks noGrp="1"/>
          </p:cNvSpPr>
          <p:nvPr>
            <p:ph/>
          </p:nvPr>
        </p:nvSpPr>
        <p:spPr>
          <a:xfrm>
            <a:off x="3972600" y="2353320"/>
            <a:ext cx="3413160" cy="5833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9DA3B038-1F45-4DF4-89D3-EBF713594598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388440" y="401040"/>
            <a:ext cx="6994800" cy="167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D34170A-7E11-45E4-B451-2C6A65C0820A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subTitle"/>
          </p:nvPr>
        </p:nvSpPr>
        <p:spPr>
          <a:xfrm>
            <a:off x="388440" y="401040"/>
            <a:ext cx="6994800" cy="778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9FF65228-7BA4-42F3-82E2-621B2202CA08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388440" y="401040"/>
            <a:ext cx="6994800" cy="167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/>
          </p:nvPr>
        </p:nvSpPr>
        <p:spPr>
          <a:xfrm>
            <a:off x="388440" y="2353320"/>
            <a:ext cx="3413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12" name="PlaceHolder 3"/>
          <p:cNvSpPr>
            <a:spLocks noGrp="1"/>
          </p:cNvSpPr>
          <p:nvPr>
            <p:ph/>
          </p:nvPr>
        </p:nvSpPr>
        <p:spPr>
          <a:xfrm>
            <a:off x="3972600" y="2353320"/>
            <a:ext cx="3413160" cy="5833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13" name="PlaceHolder 4"/>
          <p:cNvSpPr>
            <a:spLocks noGrp="1"/>
          </p:cNvSpPr>
          <p:nvPr>
            <p:ph/>
          </p:nvPr>
        </p:nvSpPr>
        <p:spPr>
          <a:xfrm>
            <a:off x="388440" y="5400360"/>
            <a:ext cx="3413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2BC02D6-3778-4740-8DC5-2A86840315D6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88440" y="401040"/>
            <a:ext cx="6994800" cy="167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88440" y="2353320"/>
            <a:ext cx="3413160" cy="5833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972600" y="2353320"/>
            <a:ext cx="3413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972600" y="5400360"/>
            <a:ext cx="3413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4957D32-3750-4C88-89F0-12EAF6023B65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88440" y="401040"/>
            <a:ext cx="6994800" cy="1679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88440" y="2353320"/>
            <a:ext cx="3413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972600" y="2353320"/>
            <a:ext cx="341316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88440" y="5400360"/>
            <a:ext cx="6994800" cy="2782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Lucida Grand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DC281C55-045C-428D-BC28-77B0748BA124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sldNum" idx="1"/>
          </p:nvPr>
        </p:nvSpPr>
        <p:spPr>
          <a:xfrm>
            <a:off x="7100640" y="9589680"/>
            <a:ext cx="282600" cy="26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78787"/>
                </a:solidFill>
                <a:latin typeface="Lucida Grande"/>
                <a:ea typeface="Lucida Grand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784FAC2-BB1E-4C4E-B700-EBC053D6F71E}" type="slidenum">
              <a:rPr b="0" lang="en-US" sz="1200" spc="-1" strike="noStrike">
                <a:solidFill>
                  <a:srgbClr val="878787"/>
                </a:solidFill>
                <a:latin typeface="Lucida Grande"/>
                <a:ea typeface="Lucida Grande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Rectangle 1"/>
          <p:cNvSpPr/>
          <p:nvPr/>
        </p:nvSpPr>
        <p:spPr>
          <a:xfrm>
            <a:off x="76320" y="0"/>
            <a:ext cx="2539800" cy="3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8160" rIns="38160" tIns="38160" bIns="38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 Bold"/>
                <a:ea typeface="Times New Roman Bold"/>
              </a:rPr>
              <a:t>Supplemental Figure 2</a:t>
            </a:r>
            <a:endParaRPr b="0" lang="en-US" sz="1800" spc="-1" strike="noStrike">
              <a:solidFill>
                <a:srgbClr val="000000"/>
              </a:solidFill>
              <a:latin typeface="Gill Sans"/>
            </a:endParaRPr>
          </a:p>
        </p:txBody>
      </p:sp>
      <p:grpSp>
        <p:nvGrpSpPr>
          <p:cNvPr id="38" name="Group 43"/>
          <p:cNvGrpSpPr/>
          <p:nvPr/>
        </p:nvGrpSpPr>
        <p:grpSpPr>
          <a:xfrm>
            <a:off x="150840" y="1062000"/>
            <a:ext cx="7478280" cy="3357000"/>
            <a:chOff x="150840" y="1062000"/>
            <a:chExt cx="7478280" cy="3357000"/>
          </a:xfrm>
        </p:grpSpPr>
        <p:grpSp>
          <p:nvGrpSpPr>
            <p:cNvPr id="39" name="Group 41"/>
            <p:cNvGrpSpPr/>
            <p:nvPr/>
          </p:nvGrpSpPr>
          <p:grpSpPr>
            <a:xfrm>
              <a:off x="150840" y="1062000"/>
              <a:ext cx="7430040" cy="3357000"/>
              <a:chOff x="150840" y="1062000"/>
              <a:chExt cx="7430040" cy="3357000"/>
            </a:xfrm>
          </p:grpSpPr>
          <p:sp>
            <p:nvSpPr>
              <p:cNvPr id="40" name="Rectangle 2"/>
              <p:cNvSpPr/>
              <p:nvPr/>
            </p:nvSpPr>
            <p:spPr>
              <a:xfrm>
                <a:off x="2208240" y="1062000"/>
                <a:ext cx="787320" cy="266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8160" rIns="38160" tIns="38160" bIns="381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Times New Roman Bold"/>
                    <a:ea typeface="Times New Roman Bold"/>
                  </a:rPr>
                  <a:t>48 Hrs</a:t>
                </a:r>
                <a:endParaRPr b="0" lang="en-US" sz="14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41" name="Rectangle 3"/>
              <p:cNvSpPr/>
              <p:nvPr/>
            </p:nvSpPr>
            <p:spPr>
              <a:xfrm>
                <a:off x="5826960" y="1062000"/>
                <a:ext cx="787320" cy="266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8160" rIns="38160" tIns="38160" bIns="381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Times New Roman Bold"/>
                    <a:ea typeface="Times New Roman Bold"/>
                  </a:rPr>
                  <a:t>72 Hrs</a:t>
                </a:r>
                <a:endParaRPr b="0" lang="en-US" sz="14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42" name="Rectangle 4"/>
              <p:cNvSpPr/>
              <p:nvPr/>
            </p:nvSpPr>
            <p:spPr>
              <a:xfrm>
                <a:off x="320760" y="3047040"/>
                <a:ext cx="950760" cy="29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8160" rIns="38160" tIns="38160" bIns="381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 Bold"/>
                    <a:ea typeface="Times New Roman Bold"/>
                  </a:rPr>
                  <a:t>p70S6K</a:t>
                </a:r>
                <a:endParaRPr b="0" lang="en-US" sz="1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43" name="Rectangle 5"/>
              <p:cNvSpPr/>
              <p:nvPr/>
            </p:nvSpPr>
            <p:spPr>
              <a:xfrm>
                <a:off x="257040" y="2016360"/>
                <a:ext cx="1082880" cy="29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8160" rIns="38160" tIns="38160" bIns="381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 Bold"/>
                    <a:ea typeface="Times New Roman Bold"/>
                  </a:rPr>
                  <a:t>p-mTOR</a:t>
                </a:r>
                <a:endParaRPr b="0" lang="en-US" sz="1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grpSp>
            <p:nvGrpSpPr>
              <p:cNvPr id="44" name="Group 12"/>
              <p:cNvGrpSpPr/>
              <p:nvPr/>
            </p:nvGrpSpPr>
            <p:grpSpPr>
              <a:xfrm>
                <a:off x="1521000" y="1446120"/>
                <a:ext cx="2857680" cy="285480"/>
                <a:chOff x="1521000" y="1446120"/>
                <a:chExt cx="2857680" cy="285480"/>
              </a:xfrm>
            </p:grpSpPr>
            <p:sp>
              <p:nvSpPr>
                <p:cNvPr id="45" name="Rectangle 6"/>
                <p:cNvSpPr/>
                <p:nvPr/>
              </p:nvSpPr>
              <p:spPr>
                <a:xfrm>
                  <a:off x="1521000" y="1446120"/>
                  <a:ext cx="825480" cy="255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38160" rIns="38160" tIns="38160" bIns="3816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 Bold"/>
                      <a:ea typeface="Times New Roman Bold"/>
                    </a:rPr>
                    <a:t>MCF-7</a:t>
                  </a:r>
                  <a:endParaRPr b="0" lang="en-US" sz="1200" spc="-1" strike="noStrike">
                    <a:solidFill>
                      <a:srgbClr val="000000"/>
                    </a:solidFill>
                    <a:latin typeface="Gill Sans"/>
                  </a:endParaRPr>
                </a:p>
              </p:txBody>
            </p:sp>
            <p:sp>
              <p:nvSpPr>
                <p:cNvPr id="46" name="Rectangle 7"/>
                <p:cNvSpPr/>
                <p:nvPr/>
              </p:nvSpPr>
              <p:spPr>
                <a:xfrm>
                  <a:off x="2302200" y="1446120"/>
                  <a:ext cx="1206360" cy="255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38160" rIns="38160" tIns="38160" bIns="3816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 Bold"/>
                      <a:ea typeface="Times New Roman Bold"/>
                    </a:rPr>
                    <a:t>MCF-7:5C</a:t>
                  </a:r>
                  <a:endParaRPr b="0" lang="en-US" sz="1200" spc="-1" strike="noStrike">
                    <a:solidFill>
                      <a:srgbClr val="000000"/>
                    </a:solidFill>
                    <a:latin typeface="Gill Sans"/>
                  </a:endParaRPr>
                </a:p>
              </p:txBody>
            </p:sp>
            <p:sp>
              <p:nvSpPr>
                <p:cNvPr id="47" name="Line 8"/>
                <p:cNvSpPr/>
                <p:nvPr/>
              </p:nvSpPr>
              <p:spPr>
                <a:xfrm>
                  <a:off x="1521000" y="1731600"/>
                  <a:ext cx="68580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4200" spc="-1" strike="noStrike">
                    <a:solidFill>
                      <a:srgbClr val="000000"/>
                    </a:solidFill>
                    <a:latin typeface="Gill Sans"/>
                  </a:endParaRPr>
                </a:p>
              </p:txBody>
            </p:sp>
            <p:sp>
              <p:nvSpPr>
                <p:cNvPr id="48" name="Rectangle 9"/>
                <p:cNvSpPr/>
                <p:nvPr/>
              </p:nvSpPr>
              <p:spPr>
                <a:xfrm>
                  <a:off x="3273480" y="1446120"/>
                  <a:ext cx="1105200" cy="255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38160" rIns="38160" tIns="38160" bIns="3816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 Bold"/>
                      <a:ea typeface="Times New Roman Bold"/>
                    </a:rPr>
                    <a:t>MCF-7:2A</a:t>
                  </a:r>
                  <a:endParaRPr b="0" lang="en-US" sz="1200" spc="-1" strike="noStrike">
                    <a:solidFill>
                      <a:srgbClr val="000000"/>
                    </a:solidFill>
                    <a:latin typeface="Gill Sans"/>
                  </a:endParaRPr>
                </a:p>
              </p:txBody>
            </p:sp>
            <p:sp>
              <p:nvSpPr>
                <p:cNvPr id="49" name="Line 10"/>
                <p:cNvSpPr/>
                <p:nvPr/>
              </p:nvSpPr>
              <p:spPr>
                <a:xfrm>
                  <a:off x="2430720" y="1731600"/>
                  <a:ext cx="68580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4200" spc="-1" strike="noStrike">
                    <a:solidFill>
                      <a:srgbClr val="000000"/>
                    </a:solidFill>
                    <a:latin typeface="Gill Sans"/>
                  </a:endParaRPr>
                </a:p>
              </p:txBody>
            </p:sp>
            <p:sp>
              <p:nvSpPr>
                <p:cNvPr id="50" name="Line 11"/>
                <p:cNvSpPr/>
                <p:nvPr/>
              </p:nvSpPr>
              <p:spPr>
                <a:xfrm>
                  <a:off x="3380040" y="1731600"/>
                  <a:ext cx="68580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4200" spc="-1" strike="noStrike">
                    <a:solidFill>
                      <a:srgbClr val="000000"/>
                    </a:solidFill>
                    <a:latin typeface="Gill Sans"/>
                  </a:endParaRPr>
                </a:p>
              </p:txBody>
            </p:sp>
          </p:grpSp>
          <p:sp>
            <p:nvSpPr>
              <p:cNvPr id="51" name="Rectangle 13"/>
              <p:cNvSpPr/>
              <p:nvPr/>
            </p:nvSpPr>
            <p:spPr>
              <a:xfrm>
                <a:off x="150840" y="2711880"/>
                <a:ext cx="1120680" cy="29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8160" rIns="38160" tIns="38160" bIns="381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 Bold"/>
                    <a:ea typeface="Times New Roman Bold"/>
                  </a:rPr>
                  <a:t>p-p70S6K</a:t>
                </a:r>
                <a:endParaRPr b="0" lang="en-US" sz="1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52" name="Rectangle 14"/>
              <p:cNvSpPr/>
              <p:nvPr/>
            </p:nvSpPr>
            <p:spPr>
              <a:xfrm>
                <a:off x="378000" y="2360880"/>
                <a:ext cx="871560" cy="29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8160" rIns="38160" tIns="38160" bIns="381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 Bold"/>
                    <a:ea typeface="Times New Roman Bold"/>
                  </a:rPr>
                  <a:t>mTOR</a:t>
                </a:r>
                <a:endParaRPr b="0" lang="en-US" sz="1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53" name="Rectangle 15"/>
              <p:cNvSpPr/>
              <p:nvPr/>
            </p:nvSpPr>
            <p:spPr>
              <a:xfrm>
                <a:off x="673200" y="3733200"/>
                <a:ext cx="635040" cy="29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8160" rIns="38160" tIns="38160" bIns="381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 Bold"/>
                    <a:ea typeface="Times New Roman Bold"/>
                  </a:rPr>
                  <a:t>Akt</a:t>
                </a:r>
                <a:endParaRPr b="0" lang="en-US" sz="1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54" name="Rectangle 16"/>
              <p:cNvSpPr/>
              <p:nvPr/>
            </p:nvSpPr>
            <p:spPr>
              <a:xfrm>
                <a:off x="368280" y="4084200"/>
                <a:ext cx="903240" cy="29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8160" rIns="38160" tIns="38160" bIns="381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 Bold"/>
                    <a:ea typeface="Times New Roman Bold"/>
                  </a:rPr>
                  <a:t>β-actin</a:t>
                </a:r>
                <a:endParaRPr b="0" lang="en-US" sz="1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pic>
            <p:nvPicPr>
              <p:cNvPr id="55" name="Picture 17" descr=""/>
              <p:cNvPicPr/>
              <p:nvPr/>
            </p:nvPicPr>
            <p:blipFill>
              <a:blip r:embed="rId1">
                <a:grayscl/>
              </a:blip>
              <a:srcRect l="26373" t="24825" r="6247" b="23928"/>
              <a:stretch/>
            </p:blipFill>
            <p:spPr>
              <a:xfrm>
                <a:off x="1366920" y="4146120"/>
                <a:ext cx="2899080" cy="27288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  <a:effectLst>
                <a:outerShdw dist="38183" dir="2700000" blurRad="0" rotWithShape="0">
                  <a:srgbClr val="000000">
                    <a:alpha val="40000"/>
                  </a:srgbClr>
                </a:outerShdw>
              </a:effectLst>
            </p:spPr>
          </p:pic>
          <p:pic>
            <p:nvPicPr>
              <p:cNvPr id="56" name="Picture 18" descr=""/>
              <p:cNvPicPr/>
              <p:nvPr/>
            </p:nvPicPr>
            <p:blipFill>
              <a:blip r:embed="rId2">
                <a:grayscl/>
              </a:blip>
              <a:srcRect l="31002" t="0" r="3617" b="0"/>
              <a:stretch/>
            </p:blipFill>
            <p:spPr>
              <a:xfrm>
                <a:off x="1370160" y="3467880"/>
                <a:ext cx="2895840" cy="26496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  <a:effectLst>
                <a:outerShdw dist="38183" dir="2700000" blurRad="0" rotWithShape="0">
                  <a:srgbClr val="000000">
                    <a:alpha val="40000"/>
                  </a:srgbClr>
                </a:outerShdw>
              </a:effectLst>
            </p:spPr>
          </p:pic>
          <p:sp>
            <p:nvSpPr>
              <p:cNvPr id="57" name="Rectangle 19"/>
              <p:cNvSpPr/>
              <p:nvPr/>
            </p:nvSpPr>
            <p:spPr>
              <a:xfrm>
                <a:off x="520560" y="3367800"/>
                <a:ext cx="831960" cy="288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8160" rIns="38160" tIns="38160" bIns="381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 Bold"/>
                    <a:ea typeface="Times New Roman Bold"/>
                  </a:rPr>
                  <a:t>p-Akt</a:t>
                </a:r>
                <a:endParaRPr b="0" lang="en-US" sz="1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pic>
            <p:nvPicPr>
              <p:cNvPr id="58" name="Picture 20" descr=""/>
              <p:cNvPicPr/>
              <p:nvPr/>
            </p:nvPicPr>
            <p:blipFill>
              <a:blip r:embed="rId3">
                <a:grayscl/>
              </a:blip>
              <a:srcRect l="26329" t="25353" r="3705" b="7560"/>
              <a:stretch/>
            </p:blipFill>
            <p:spPr>
              <a:xfrm>
                <a:off x="1366920" y="2075040"/>
                <a:ext cx="2899080" cy="27468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  <a:effectLst>
                <a:outerShdw dist="38183" dir="2700000" blurRad="0" rotWithShape="0">
                  <a:srgbClr val="000000">
                    <a:alpha val="40000"/>
                  </a:srgbClr>
                </a:outerShdw>
              </a:effectLst>
            </p:spPr>
          </p:pic>
          <p:pic>
            <p:nvPicPr>
              <p:cNvPr id="59" name="Picture 21" descr=""/>
              <p:cNvPicPr/>
              <p:nvPr/>
            </p:nvPicPr>
            <p:blipFill>
              <a:blip r:embed="rId4">
                <a:grayscl/>
              </a:blip>
              <a:srcRect l="24355" t="20966" r="3094" b="28399"/>
              <a:stretch/>
            </p:blipFill>
            <p:spPr>
              <a:xfrm>
                <a:off x="1370160" y="3108960"/>
                <a:ext cx="2895840" cy="27468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  <a:effectLst>
                <a:outerShdw dist="38183" dir="2700000" blurRad="0" rotWithShape="0">
                  <a:srgbClr val="000000">
                    <a:alpha val="40000"/>
                  </a:srgbClr>
                </a:outerShdw>
              </a:effectLst>
            </p:spPr>
          </p:pic>
          <p:pic>
            <p:nvPicPr>
              <p:cNvPr id="60" name="Picture 22" descr=""/>
              <p:cNvPicPr/>
              <p:nvPr/>
            </p:nvPicPr>
            <p:blipFill>
              <a:blip r:embed="rId5">
                <a:grayscl/>
              </a:blip>
              <a:srcRect l="23142" t="659" r="5002" b="31172"/>
              <a:stretch/>
            </p:blipFill>
            <p:spPr>
              <a:xfrm>
                <a:off x="1366920" y="2774160"/>
                <a:ext cx="2899080" cy="27288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  <a:effectLst>
                <a:outerShdw dist="38183" dir="2700000" blurRad="0" rotWithShape="0">
                  <a:srgbClr val="000000">
                    <a:alpha val="40000"/>
                  </a:srgbClr>
                </a:outerShdw>
              </a:effectLst>
            </p:spPr>
          </p:pic>
          <p:pic>
            <p:nvPicPr>
              <p:cNvPr id="61" name="Picture 23" descr=""/>
              <p:cNvPicPr/>
              <p:nvPr/>
            </p:nvPicPr>
            <p:blipFill>
              <a:blip r:embed="rId6"/>
              <a:srcRect l="33763" t="14716" r="5422" b="30301"/>
              <a:stretch/>
            </p:blipFill>
            <p:spPr>
              <a:xfrm>
                <a:off x="1366920" y="2427480"/>
                <a:ext cx="2899080" cy="27324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  <a:effectLst>
                <a:outerShdw dist="38183" dir="2700000" blurRad="0" rotWithShape="0">
                  <a:srgbClr val="000000">
                    <a:alpha val="40000"/>
                  </a:srgbClr>
                </a:outerShdw>
              </a:effectLst>
            </p:spPr>
          </p:pic>
          <p:pic>
            <p:nvPicPr>
              <p:cNvPr id="62" name="Picture 24" descr=""/>
              <p:cNvPicPr/>
              <p:nvPr/>
            </p:nvPicPr>
            <p:blipFill>
              <a:blip r:embed="rId7"/>
              <a:srcRect l="4806" t="8025" r="3161" b="1529"/>
              <a:stretch/>
            </p:blipFill>
            <p:spPr>
              <a:xfrm>
                <a:off x="1370160" y="3809520"/>
                <a:ext cx="2895840" cy="269640"/>
              </a:xfrm>
              <a:prstGeom prst="rect">
                <a:avLst/>
              </a:prstGeom>
              <a:ln cap="sq" w="3240">
                <a:solidFill>
                  <a:srgbClr val="000000"/>
                </a:solidFill>
                <a:miter/>
              </a:ln>
              <a:effectLst>
                <a:outerShdw dist="38183" dir="2700000" blurRad="0" rotWithShape="0">
                  <a:srgbClr val="000000">
                    <a:alpha val="40000"/>
                  </a:srgbClr>
                </a:outerShdw>
              </a:effectLst>
            </p:spPr>
          </p:pic>
          <p:sp>
            <p:nvSpPr>
              <p:cNvPr id="63" name="Rectangle 25"/>
              <p:cNvSpPr/>
              <p:nvPr/>
            </p:nvSpPr>
            <p:spPr>
              <a:xfrm>
                <a:off x="291960" y="1747800"/>
                <a:ext cx="1105200" cy="266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8160" rIns="38160" tIns="38160" bIns="381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EVE (nM)</a:t>
                </a:r>
                <a:endParaRPr b="0" lang="en-US" sz="14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4" name="Rectangle 26"/>
              <p:cNvSpPr/>
              <p:nvPr/>
            </p:nvSpPr>
            <p:spPr>
              <a:xfrm>
                <a:off x="1494000" y="1785960"/>
                <a:ext cx="2934000" cy="216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38160" rIns="38160" tIns="38160" bIns="3816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 Bold"/>
                    <a:ea typeface="Times New Roman Bold"/>
                  </a:rPr>
                  <a:t>0           20           0           20            0           20</a:t>
                </a:r>
                <a:endParaRPr b="0" lang="en-US" sz="10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pic>
            <p:nvPicPr>
              <p:cNvPr id="65" name="Picture 27" descr=""/>
              <p:cNvPicPr/>
              <p:nvPr/>
            </p:nvPicPr>
            <p:blipFill>
              <a:blip r:embed="rId8">
                <a:grayscl/>
              </a:blip>
              <a:srcRect l="26741" t="31042" r="6897" b="28599"/>
              <a:stretch/>
            </p:blipFill>
            <p:spPr>
              <a:xfrm>
                <a:off x="4570920" y="2075040"/>
                <a:ext cx="2929320" cy="27468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  <a:effectLst>
                <a:outerShdw dist="38183" dir="2700000" blurRad="0" rotWithShape="0">
                  <a:srgbClr val="000000">
                    <a:alpha val="40000"/>
                  </a:srgbClr>
                </a:outerShdw>
              </a:effectLst>
            </p:spPr>
          </p:pic>
          <p:grpSp>
            <p:nvGrpSpPr>
              <p:cNvPr id="66" name="Group 34"/>
              <p:cNvGrpSpPr/>
              <p:nvPr/>
            </p:nvGrpSpPr>
            <p:grpSpPr>
              <a:xfrm>
                <a:off x="4739040" y="1446120"/>
                <a:ext cx="2841840" cy="285480"/>
                <a:chOff x="4739040" y="1446120"/>
                <a:chExt cx="2841840" cy="285480"/>
              </a:xfrm>
            </p:grpSpPr>
            <p:sp>
              <p:nvSpPr>
                <p:cNvPr id="67" name="Rectangle 28"/>
                <p:cNvSpPr/>
                <p:nvPr/>
              </p:nvSpPr>
              <p:spPr>
                <a:xfrm>
                  <a:off x="4739040" y="1446120"/>
                  <a:ext cx="825840" cy="255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38160" rIns="38160" tIns="38160" bIns="3816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 Bold"/>
                      <a:ea typeface="Times New Roman Bold"/>
                    </a:rPr>
                    <a:t>MCF-7</a:t>
                  </a:r>
                  <a:endParaRPr b="0" lang="en-US" sz="1200" spc="-1" strike="noStrike">
                    <a:solidFill>
                      <a:srgbClr val="000000"/>
                    </a:solidFill>
                    <a:latin typeface="Gill Sans"/>
                  </a:endParaRPr>
                </a:p>
              </p:txBody>
            </p:sp>
            <p:sp>
              <p:nvSpPr>
                <p:cNvPr id="68" name="Rectangle 29"/>
                <p:cNvSpPr/>
                <p:nvPr/>
              </p:nvSpPr>
              <p:spPr>
                <a:xfrm>
                  <a:off x="5590440" y="1446120"/>
                  <a:ext cx="1207080" cy="255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38160" rIns="38160" tIns="38160" bIns="3816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 Bold"/>
                      <a:ea typeface="Times New Roman Bold"/>
                    </a:rPr>
                    <a:t>MCF-7:5C</a:t>
                  </a:r>
                  <a:endParaRPr b="0" lang="en-US" sz="1200" spc="-1" strike="noStrike">
                    <a:solidFill>
                      <a:srgbClr val="000000"/>
                    </a:solidFill>
                    <a:latin typeface="Gill Sans"/>
                  </a:endParaRPr>
                </a:p>
              </p:txBody>
            </p:sp>
            <p:sp>
              <p:nvSpPr>
                <p:cNvPr id="69" name="Line 30"/>
                <p:cNvSpPr/>
                <p:nvPr/>
              </p:nvSpPr>
              <p:spPr>
                <a:xfrm>
                  <a:off x="4770720" y="1731600"/>
                  <a:ext cx="68616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4200" spc="-1" strike="noStrike">
                    <a:solidFill>
                      <a:srgbClr val="000000"/>
                    </a:solidFill>
                    <a:latin typeface="Gill Sans"/>
                  </a:endParaRPr>
                </a:p>
              </p:txBody>
            </p:sp>
            <p:sp>
              <p:nvSpPr>
                <p:cNvPr id="70" name="Rectangle 31"/>
                <p:cNvSpPr/>
                <p:nvPr/>
              </p:nvSpPr>
              <p:spPr>
                <a:xfrm>
                  <a:off x="6475320" y="1446120"/>
                  <a:ext cx="1105560" cy="255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38160" rIns="38160" tIns="38160" bIns="38160" anchor="t">
                  <a:no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 Bold"/>
                      <a:ea typeface="Times New Roman Bold"/>
                    </a:rPr>
                    <a:t>MCF-7:2A</a:t>
                  </a:r>
                  <a:endParaRPr b="0" lang="en-US" sz="1200" spc="-1" strike="noStrike">
                    <a:solidFill>
                      <a:srgbClr val="000000"/>
                    </a:solidFill>
                    <a:latin typeface="Gill Sans"/>
                  </a:endParaRPr>
                </a:p>
              </p:txBody>
            </p:sp>
            <p:sp>
              <p:nvSpPr>
                <p:cNvPr id="71" name="Line 32"/>
                <p:cNvSpPr/>
                <p:nvPr/>
              </p:nvSpPr>
              <p:spPr>
                <a:xfrm>
                  <a:off x="5712840" y="1731600"/>
                  <a:ext cx="68616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4200" spc="-1" strike="noStrike">
                    <a:solidFill>
                      <a:srgbClr val="000000"/>
                    </a:solidFill>
                    <a:latin typeface="Gill Sans"/>
                  </a:endParaRPr>
                </a:p>
              </p:txBody>
            </p:sp>
            <p:sp>
              <p:nvSpPr>
                <p:cNvPr id="72" name="Line 33"/>
                <p:cNvSpPr/>
                <p:nvPr/>
              </p:nvSpPr>
              <p:spPr>
                <a:xfrm>
                  <a:off x="6583320" y="1731600"/>
                  <a:ext cx="68616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4200" spc="-1" strike="noStrike">
                    <a:solidFill>
                      <a:srgbClr val="000000"/>
                    </a:solidFill>
                    <a:latin typeface="Gill Sans"/>
                  </a:endParaRPr>
                </a:p>
              </p:txBody>
            </p:sp>
          </p:grpSp>
          <p:pic>
            <p:nvPicPr>
              <p:cNvPr id="73" name="Picture 35" descr=""/>
              <p:cNvPicPr/>
              <p:nvPr/>
            </p:nvPicPr>
            <p:blipFill>
              <a:blip r:embed="rId9">
                <a:grayscl/>
              </a:blip>
              <a:srcRect l="25395" t="42228" r="4705" b="23365"/>
              <a:stretch/>
            </p:blipFill>
            <p:spPr>
              <a:xfrm>
                <a:off x="4570920" y="2427480"/>
                <a:ext cx="2934000" cy="27324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  <a:effectLst>
                <a:outerShdw dist="38183" dir="2700000" blurRad="0" rotWithShape="0">
                  <a:srgbClr val="000000">
                    <a:alpha val="40000"/>
                  </a:srgbClr>
                </a:outerShdw>
              </a:effectLst>
            </p:spPr>
          </p:pic>
          <p:pic>
            <p:nvPicPr>
              <p:cNvPr id="74" name="Picture 36" descr=""/>
              <p:cNvPicPr/>
              <p:nvPr/>
            </p:nvPicPr>
            <p:blipFill>
              <a:blip r:embed="rId10">
                <a:grayscl/>
              </a:blip>
              <a:srcRect l="29734" t="10670" r="6786" b="28182"/>
              <a:stretch/>
            </p:blipFill>
            <p:spPr>
              <a:xfrm>
                <a:off x="4570920" y="4146120"/>
                <a:ext cx="2934000" cy="27288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  <a:effectLst>
                <a:outerShdw dist="38183" dir="2700000" blurRad="0" rotWithShape="0">
                  <a:srgbClr val="000000">
                    <a:alpha val="40000"/>
                  </a:srgbClr>
                </a:outerShdw>
              </a:effectLst>
            </p:spPr>
          </p:pic>
          <p:pic>
            <p:nvPicPr>
              <p:cNvPr id="75" name="Picture 37" descr=""/>
              <p:cNvPicPr/>
              <p:nvPr/>
            </p:nvPicPr>
            <p:blipFill>
              <a:blip r:embed="rId11">
                <a:grayscl/>
              </a:blip>
              <a:srcRect l="27089" t="22182" r="13058" b="21651"/>
              <a:stretch/>
            </p:blipFill>
            <p:spPr>
              <a:xfrm>
                <a:off x="4570920" y="3108960"/>
                <a:ext cx="2934000" cy="27468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  <a:effectLst>
                <a:outerShdw dist="38183" dir="2700000" blurRad="0" rotWithShape="0">
                  <a:srgbClr val="000000">
                    <a:alpha val="40000"/>
                  </a:srgbClr>
                </a:outerShdw>
              </a:effectLst>
            </p:spPr>
          </p:pic>
          <p:pic>
            <p:nvPicPr>
              <p:cNvPr id="76" name="Picture 38" descr=""/>
              <p:cNvPicPr/>
              <p:nvPr/>
            </p:nvPicPr>
            <p:blipFill>
              <a:blip r:embed="rId12">
                <a:grayscl/>
              </a:blip>
              <a:srcRect l="25487" t="0" r="4739" b="3568"/>
              <a:stretch/>
            </p:blipFill>
            <p:spPr>
              <a:xfrm>
                <a:off x="4570920" y="2780280"/>
                <a:ext cx="2934000" cy="26676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  <a:effectLst>
                <a:outerShdw dist="38183" dir="2700000" blurRad="0" rotWithShape="0">
                  <a:srgbClr val="000000">
                    <a:alpha val="40000"/>
                  </a:srgbClr>
                </a:outerShdw>
              </a:effectLst>
            </p:spPr>
          </p:pic>
          <p:pic>
            <p:nvPicPr>
              <p:cNvPr id="77" name="Picture 39" descr=""/>
              <p:cNvPicPr/>
              <p:nvPr/>
            </p:nvPicPr>
            <p:blipFill>
              <a:blip r:embed="rId13"/>
              <a:srcRect l="0" t="12841" r="1422" b="21188"/>
              <a:stretch/>
            </p:blipFill>
            <p:spPr>
              <a:xfrm>
                <a:off x="4569120" y="3459960"/>
                <a:ext cx="2931120" cy="272880"/>
              </a:xfrm>
              <a:prstGeom prst="rect">
                <a:avLst/>
              </a:prstGeom>
              <a:ln cap="sq" w="3240">
                <a:solidFill>
                  <a:srgbClr val="000000"/>
                </a:solidFill>
                <a:miter/>
              </a:ln>
              <a:effectLst>
                <a:outerShdw dist="38183" dir="2700000" blurRad="0" rotWithShape="0">
                  <a:srgbClr val="000000">
                    <a:alpha val="40000"/>
                  </a:srgbClr>
                </a:outerShdw>
              </a:effectLst>
            </p:spPr>
          </p:pic>
          <p:pic>
            <p:nvPicPr>
              <p:cNvPr id="78" name="Picture 40" descr=""/>
              <p:cNvPicPr/>
              <p:nvPr/>
            </p:nvPicPr>
            <p:blipFill>
              <a:blip r:embed="rId14"/>
              <a:srcRect l="951" t="0" r="6311" b="0"/>
              <a:stretch/>
            </p:blipFill>
            <p:spPr>
              <a:xfrm>
                <a:off x="4570920" y="3809520"/>
                <a:ext cx="2934000" cy="274680"/>
              </a:xfrm>
              <a:prstGeom prst="rect">
                <a:avLst/>
              </a:prstGeom>
              <a:ln cap="sq" w="3240">
                <a:solidFill>
                  <a:srgbClr val="000000"/>
                </a:solidFill>
                <a:miter/>
              </a:ln>
              <a:effectLst>
                <a:outerShdw dist="38183" dir="2700000" blurRad="0" rotWithShape="0">
                  <a:srgbClr val="000000">
                    <a:alpha val="40000"/>
                  </a:srgbClr>
                </a:outerShdw>
              </a:effectLst>
            </p:spPr>
          </p:pic>
        </p:grpSp>
        <p:sp>
          <p:nvSpPr>
            <p:cNvPr id="79" name="Rectangle 42"/>
            <p:cNvSpPr/>
            <p:nvPr/>
          </p:nvSpPr>
          <p:spPr>
            <a:xfrm>
              <a:off x="4695120" y="1746720"/>
              <a:ext cx="293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38160" rIns="38160" tIns="38160" bIns="381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 Bold"/>
                  <a:ea typeface="Times New Roman Bold"/>
                </a:rPr>
                <a:t>0           20            0            20            0           20</a:t>
              </a:r>
              <a:endParaRPr b="0" lang="en-US" sz="1000" spc="-1" strike="noStrike">
                <a:solidFill>
                  <a:srgbClr val="000000"/>
                </a:solidFill>
                <a:latin typeface="Gill Sans"/>
              </a:endParaRPr>
            </a:p>
          </p:txBody>
        </p:sp>
      </p:grpSp>
      <p:sp>
        <p:nvSpPr>
          <p:cNvPr id="80" name="Rectangle 44"/>
          <p:cNvSpPr/>
          <p:nvPr/>
        </p:nvSpPr>
        <p:spPr>
          <a:xfrm>
            <a:off x="368280" y="5156280"/>
            <a:ext cx="7061400" cy="673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just">
              <a:lnSpc>
                <a:spcPct val="110000"/>
              </a:lnSpc>
              <a:spcBef>
                <a:spcPts val="11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 Bold"/>
                <a:ea typeface="Times New Roman Bold"/>
              </a:rPr>
              <a:t>Supplemental Fig. 2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verolimus targets the phosphorylation of the PI3K/mTOR/Akt pathway at 48 and 72 hours</a:t>
            </a:r>
            <a:endParaRPr b="0" lang="en-US" sz="1200" spc="-1" strike="noStrike">
              <a:solidFill>
                <a:srgbClr val="000000"/>
              </a:solidFill>
              <a:latin typeface="Gill Sans"/>
            </a:endParaRPr>
          </a:p>
          <a:p>
            <a:pPr algn="just">
              <a:lnSpc>
                <a:spcPct val="11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CF-7, MCF-7:5C and MCF-7:2A cells were seeded in 6-well plates and treated with 25, 50 or 100 nM everolimus or vehicle. Cells were harvested at 48 and 72 hours and protein expression analyzed by western blot.</a:t>
            </a:r>
            <a:endParaRPr b="0" lang="en-US" sz="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Asona Lui</dc:creator>
  <dc:description/>
  <dc:language>en-US</dc:language>
  <cp:lastModifiedBy>Asona Lui</cp:lastModifiedBy>
  <dcterms:modified xsi:type="dcterms:W3CDTF">2016-02-16T17:29:02Z</dcterms:modified>
  <cp:revision>1</cp:revision>
  <dc:subject/>
  <dc:title>PowerPoint Presentation</dc:title>
</cp:coreProperties>
</file>